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58" y="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F4D1F2-E012-415F-A4F1-720466C5B4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D155B7-68E7-4E18-A0BA-71157DAEE0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BB6D2-E66E-4B9B-9575-5DCE41DAA6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E1120-0657-4B7C-84F1-FA92E34E2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410A30-2E09-4FAE-AD5B-9E75A96C2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531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F3A87B-6D7C-4337-A96E-43FD777DB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35586A-D7B0-4CB2-96C6-83047C5EA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086DC9-57F6-4F1F-8FEE-C7101D7F0B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83BBBC-B313-4B5B-BC83-0BD0DA6AAA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B31B73-4513-4812-A017-5BECCD218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427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4F4D08-F886-446B-863D-368EE2D642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A87B75-09E4-4A07-BC36-10EF3D1314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09DAEF-9F52-4F52-9B44-9005670F2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9DE1D-CF31-45D0-8313-B36831955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062AB7-E429-4E9E-A3C5-F7D4A8595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2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B2B03-EC8E-467A-868D-7A568448E1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4A76E-3B92-4D10-ABBF-6FBF526511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EC2B0-D9BD-4469-86EC-71B1B9663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2D4F7-B754-45D6-A035-F1CD2BE63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923FE1-1443-4A9E-B510-F47ADC28C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037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600B09-1B36-4EB8-865D-D58B350971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A3E53E-56AD-419A-B1B6-D8A59144FD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CB315-BF37-4041-84A0-74A69F8CE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F2EE01-9533-4653-9811-B7B7EC9C5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B0D7F-08B7-4D35-ACC6-CAEB77EA9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009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59F46-6406-471C-AD31-AE6DDC866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AEC87D-0F70-46E0-971D-463B81D683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DDD2C0-24C5-4157-A9E2-8846E11BF2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692116-39CA-4D5D-863A-4B3283759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7A34A0-3C23-4CDD-90F6-68D5116FAC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390FE2-CB6A-44F5-9A7C-82023D0B0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78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43F14-BF84-4CBE-83B8-9F16C9D713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FFB9E7-DF82-4E87-A69D-797B580D82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C99CF7-2508-468F-8845-B7B9858865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D842DF-EE9F-4A85-9CD0-119552599A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834342-BF04-46EE-B6BB-0A815F974E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FD9227-9D3C-44B7-ABBC-F1B1E6B71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4FD7BB-F7B8-4621-9724-954171F6C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AB32F3-5DFB-45F6-A2D6-60816ABDB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127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53FC20-98B7-4DD7-8871-C1A0E2EF0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8F51F9-95F9-4FD5-841C-9AC3B0303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803A18-47AA-41FB-BA34-FFECDCA4C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04D5DB-24F1-467A-94C2-34A7EA70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883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F7FDC5-9221-4868-AEB7-6CD98EE6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888F57-35EA-46C9-B895-19579B3C8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34B09F-B9CA-4978-A841-C462A6CE5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3465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0A954-E5B8-415B-8FA7-031B6D804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48332-CC18-4C25-8B63-3F6BA739AC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450835-E89B-4420-AFB4-4852F15FC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D0B98A-D3EE-4993-9DD0-5B72CAB9E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9DCD8-661F-42A0-9A7D-F3087250E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17060D-E7DA-440D-98FF-D5D8CF58A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773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9E6B9-ED30-443B-942F-0589B6E50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0C90E6-0BBD-4159-A1C5-2990C3B5E1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2BAF86-1B0D-4A6C-B3A8-6C55F1E1E4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19A152-5B55-491F-B5E7-9EE7F07F6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B3DEB8-22D8-4101-8537-D1BBA8584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CE7D22-2F40-45E6-98B6-EFA0E86D6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003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E904AA-049D-49A4-9C82-FB5060A085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C05164-1C5B-47ED-AB5A-8E635D270F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D9597A-BF87-4A90-8D83-842A94A23B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DEB71-0380-426E-B7D2-1EC071614CCF}" type="datetimeFigureOut">
              <a:rPr lang="en-US" smtClean="0"/>
              <a:t>1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C7D36-2CB4-4B97-AEC7-99F434723B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8B6924-39D2-48AE-B542-906637B6E9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37F7E7-B999-4490-9CF1-640DCEE54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318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4DB35EB3-6A46-4E99-A156-0E154EB2E479}"/>
              </a:ext>
            </a:extLst>
          </p:cNvPr>
          <p:cNvSpPr txBox="1"/>
          <p:nvPr/>
        </p:nvSpPr>
        <p:spPr>
          <a:xfrm>
            <a:off x="842682" y="663388"/>
            <a:ext cx="2662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2</a:t>
            </a:r>
          </a:p>
        </p:txBody>
      </p:sp>
      <p:pic>
        <p:nvPicPr>
          <p:cNvPr id="11" name="Picture 10" descr="A graph with colorful bars&#10;&#10;Description automatically generated">
            <a:extLst>
              <a:ext uri="{FF2B5EF4-FFF2-40B4-BE49-F238E27FC236}">
                <a16:creationId xmlns:a16="http://schemas.microsoft.com/office/drawing/2014/main" id="{4610D3AE-D1EE-45CC-9669-2EE9E20A262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846468" y="1370573"/>
            <a:ext cx="4459082" cy="3344302"/>
          </a:xfrm>
          <a:prstGeom prst="rect">
            <a:avLst/>
          </a:prstGeom>
        </p:spPr>
      </p:pic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2D83D848-899D-4501-8605-BB36E2BE4B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0057659"/>
              </p:ext>
            </p:extLst>
          </p:nvPr>
        </p:nvGraphicFramePr>
        <p:xfrm>
          <a:off x="6962775" y="1951596"/>
          <a:ext cx="4095750" cy="250610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38824">
                  <a:extLst>
                    <a:ext uri="{9D8B030D-6E8A-4147-A177-3AD203B41FA5}">
                      <a16:colId xmlns:a16="http://schemas.microsoft.com/office/drawing/2014/main" val="1401128663"/>
                    </a:ext>
                  </a:extLst>
                </a:gridCol>
                <a:gridCol w="3156926">
                  <a:extLst>
                    <a:ext uri="{9D8B030D-6E8A-4147-A177-3AD203B41FA5}">
                      <a16:colId xmlns:a16="http://schemas.microsoft.com/office/drawing/2014/main" val="3601964934"/>
                    </a:ext>
                  </a:extLst>
                </a:gridCol>
              </a:tblGrid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17.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cute renal failur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645368651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20.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Calculus of kidney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468954281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39.41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urge incontinenc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422551810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20.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Urinary calculus, unspecifie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613829375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84.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Acute kidney failure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556118869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12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Tubulo-interstitial nephritis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677858431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N39.0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Urinary tract infection, site not specified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517844411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9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Other disorders of urethra and urinary tract 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564978639"/>
                  </a:ext>
                </a:extLst>
              </a:tr>
              <a:tr h="24977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99.7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Hematuria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381837146"/>
                  </a:ext>
                </a:extLst>
              </a:tr>
              <a:tr h="25070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93.9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Unspecified disorder of kidney and ureter</a:t>
                      </a:r>
                      <a:endParaRPr lang="en-US" sz="12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466383487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7471114-52DC-464D-9A8A-3DDA10D7637D}"/>
              </a:ext>
            </a:extLst>
          </p:cNvPr>
          <p:cNvSpPr txBox="1"/>
          <p:nvPr/>
        </p:nvSpPr>
        <p:spPr>
          <a:xfrm>
            <a:off x="1962150" y="5162550"/>
            <a:ext cx="935355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Top 10 common diagnosis in genitourinary diseases (with each diagnosis code counted once per patient within the 3 months prior to their ALL/LL diagnosis, regardless of multiple occurrences)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438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84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nest Amankwah</dc:creator>
  <cp:lastModifiedBy>Ernest Amankwah</cp:lastModifiedBy>
  <cp:revision>5</cp:revision>
  <dcterms:created xsi:type="dcterms:W3CDTF">2025-01-04T14:01:47Z</dcterms:created>
  <dcterms:modified xsi:type="dcterms:W3CDTF">2025-01-04T14:25:37Z</dcterms:modified>
</cp:coreProperties>
</file>